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13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9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13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_rels/presentation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95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</p:sldMasterIdLst>
  <p:sldIdLst>
    <p:sldId id="256" r:id="rId1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slide" Target="slides/slide1.xml"/><Relationship Id="rId1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580F24-C37B-4BC2-BBEE-2A7C25AF0C4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35C501-06C4-4A87-9F94-3FB5B3C09F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362457A3-647A-44BA-9342-BD1D0F657F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489F932B-CEA8-4E61-AA08-D2961677F7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96BD5BD3-BA65-48A0-AE86-2D406E08AA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BC58494C-6FD6-4A8A-8EE5-CDF2FBC49B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1C27AAF1-669D-4864-A156-4A52D639EA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61505E4C-1855-4B44-96C5-C981D0AAD6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EEF75028-02D3-4A62-8393-207E111377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6AF0C5F8-8AB2-4E1C-AC91-BD31D7888DC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46E89F5C-B981-4F41-9E9B-D1B55F73333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3A809433-56CB-4439-BDC7-B5A93EC310F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256442-B698-4C96-B0AB-10DAA911242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0AE8039B-005C-4C02-9F49-041F7DCB7B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F630894C-284E-4C02-93A3-1EE579ABDF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56B20D2F-E2A0-49CC-9053-B9E5DA5D1F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4A7CA2C8-EA76-42E3-A14B-603874023A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10343E20-495B-4A11-A11D-5C458D02F8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A4B5A987-FF34-4500-A7E7-1DC997650A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1DC21B6E-C834-4A42-9D42-628FF7D2B5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9DE51700-3CB4-4327-84B2-986C228603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BC75681E-B0FE-4FCB-8B80-383D4AAFDB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27C55F53-A88B-4F4A-8DD4-8827A5EC4B4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D16C9A-3A5B-49AA-8260-5487A299B20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3444051E-DBB4-4509-A7C8-2A465128F3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C55BCBE2-1F87-46D8-B6F0-D4DF67BC7AD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6ADA17CB-DDF8-4F25-ABA7-6507107DDC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B66D6180-33C7-4B20-BD19-CC01BB2CB9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A2CD8EA7-5D04-4497-B244-8EE982C7CA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E34E99A7-B4A6-4E47-A3F4-0622985F09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C5FF3FD3-0F79-458D-A3F2-EBAF2F4F2D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5159A227-3DF6-4902-AF1B-49844C97B6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1401CA06-7B37-4E90-BEC1-B3018050CB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6726DFC9-0ACF-43F2-889A-0E8E32032A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793A2A98-6B95-4059-BCBE-7AA63EAA7B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4E4099FC-BEF9-4D6E-9E2E-290C803BCC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353BCE5D-0A7A-4C4D-9C3E-E27B9DCD39E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6AAF0088-B16A-4A43-B499-692446D2308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20E718D0-2D91-424D-9747-5E1852A0E0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4004612B-3793-42B8-860D-BFB88F7957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BCA929B7-1E61-4749-B570-ED4281B307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4333EB43-9700-4ED7-9A56-07608EA016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0D76861D-A4F3-4709-BB86-D792984AB7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746D66B5-60B2-47A3-93C3-19B6050D15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488CD7F4-D078-4B97-B6C6-6EEB80B734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D46B9DB2-8C71-4E7F-9C9F-F738B2EE83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47F4E29B-9569-4F90-97AE-EB872634A2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5A3FD7EC-4ADC-41EA-956E-D86E6C0C41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41A20C24-2ACD-4419-A12F-D2ABB7145A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17494B45-360A-4FB1-970C-0BAA12D935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7A398772-60C8-4901-925F-49E9182D9BE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21E3FCE3-E7C4-4743-A6CA-ECE7AC6078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2836F4FB-EC3D-4CA6-BC6F-41F5B8CE26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139AE6D4-32E4-4677-8084-636EEACF81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7A6B91F7-7B50-4A85-BAC0-244E635399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54DBD169-6F81-48C5-8596-260AEC9769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100E6C-8BAF-45AB-ADA4-9A2C399E54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7AD664EB-3BDD-41AC-9EC2-AD35DDE934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4640E877-4DB1-4DD5-A888-9ECF59E835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CCAD3260-7914-4313-BB5C-938790A4EA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D421331F-D5F7-4D33-B9DA-7ADD8299521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6D674DA1-6D17-4A8D-905A-7FF6BA2E20D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525ABC71-7448-4DC1-B8BC-40E4EF1A35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0D8AAF11-0E68-433B-B708-46CF745664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573C41A0-A6AB-48E5-A80F-62EDA9D112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7069FEA3-591B-429E-8A6B-1B4F613876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BADA8971-7B35-4F7E-AA56-90AF576EC6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2630FC-0217-4F90-AA50-45AC00E9D9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B0D6FBE7-850A-4762-8333-6BF9DEBFDC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39BD9447-F015-4FAA-BD94-4B52F885F6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8C095935-F0E2-4BFF-824B-F68E2851B8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2C084716-CFC0-40F8-BE2D-0EF3FFD069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21494397-2CA7-4684-ABDC-3B0070505C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7C002E0E-8564-4431-BE69-B80FDAC336A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9A107CEC-0633-4ABF-A77E-85EB4A289CA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2C97EAD2-9D05-4779-81ED-D93A99D4E49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4FD7F8B0-4978-47E8-92F7-E50B530B58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DFCCDCE3-A7DD-4191-B8EA-DD6DBE91C7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96F673-5F04-4335-B255-1E51715877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BC793F4E-8684-44C7-9683-B38C4EE043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F1783DE0-3C0E-446B-BBA4-B7D5A5BE8A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400BD59D-A7E3-4D80-BD13-951CE9090F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04E19CCB-5537-4DDF-986F-F252F72F71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898594ED-34D6-43D9-8011-74A182D045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C3EFE0EB-AA4B-40C3-BEB8-81289DC26A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1079D41D-E0D6-4B0F-AE2C-2CB59F5745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78E463EB-03E2-4B27-92C3-306B8CF4E5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D175871E-CE6A-4BE1-8538-1CBAE00C8CB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0ABC1F2B-99E7-4C7B-9C8E-E229355C3AB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266A6D-3289-479E-933F-A60B156A08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31952C68-4E97-4650-89B8-7232082540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1F75D16A-829F-4D68-B2CB-13AF9A32E3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BDB3CEEE-094F-485D-AE42-70487E156B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9F0CACA2-0160-49FB-B58A-78A8F1D8ED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44617E74-9E40-4BE6-8370-84CCAE39D3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0E22039E-CB19-4D9C-96B5-2F7080CA53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87151881-09D6-49AF-BDE7-8CD62E8528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36D38635-3A9D-43D9-86BC-D340668416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29BF7211-D1E8-4CC1-BF80-AF4E0AFD10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8FE4C998-B1AD-4A42-A4FD-94645D33C26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C3D2D4-7BE6-4EC6-A37E-77C762A839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8B1B29F0-2E1A-4889-ACFD-FD00A547CD0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6B6C0B57-361A-4627-B057-FF2361E6BB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970A6F29-B56F-495E-A6C3-4DB9899331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C3CAB7E3-19D3-4AA0-A447-341237A2BF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2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2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63889D3D-6DC4-456F-AADD-93787D9319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653CEA19-68D0-46E2-8660-477E717559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2BE5ACA9-5DBC-4D6B-8A68-9403630E01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2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2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2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A2CD7874-483F-40E2-BC2F-4BD02DBB6F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17A02FD4-4B86-4DED-8A1C-57F526DFC9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B2A71E77-D964-4F60-B559-41772EB85D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37A249-3BD3-442F-ABFE-59EDF1CF23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B63D3EAC-C736-4B13-9B66-B3E0E5F764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EBDC7EF5-1FA9-4B25-A9B2-1D3A66B66A7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FB0992A7-8297-41BB-BFA6-2F483CD7C9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47E414B7-CE9C-4D0F-87AF-35E6C98A37A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A3E45988-EBBB-4BA9-9DFF-37B66C2F11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FB3FF091-C013-41B9-9E0E-8D2B29FDF2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E3733CD3-1424-448C-8FAA-72CD0FF3FA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6655F3A6-EABA-4849-9E36-2FE2AC30FB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F24E332A-3EFD-47DC-8376-498E37474C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CDDC7B5D-F28A-4504-8CDF-9E0DE7F6A4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40601C-94BE-428D-A7EE-978F25AB45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9D424708-14C5-4373-A826-8B461B855D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95B33474-40A6-4666-9090-7993BBAAFE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AF476FAF-ADBB-4B6C-A396-D5DAAF65E8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44146579-A03B-4117-89BE-E92F1FB5BB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9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9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4BB43618-2657-4673-876A-B5DFDB136B9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6AB623C8-62B7-4F3C-85E6-E6F6E9EC51A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0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26E9A66D-C146-4F87-A935-5F92DC52EB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0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BF5E319F-7976-4C6B-B649-45255FD322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0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CDDD441D-51A9-4909-A9C3-849B0FF585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8E190C63-2C69-4C0D-9A20-C62F79EF9D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978D8E-46E4-47A2-B74F-52C637AC01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87D0551C-7BE6-4507-9879-32AE6D15EB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D3B29BE9-8979-4DC5-9AAF-61189E5D73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F433C611-E147-449A-8DC0-C6B1E780AB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A4BD50B6-3DA3-43F4-9912-B498F376BF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CC74A8BF-4D96-451E-8167-F899DBC117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E8339CD0-8A98-4DD5-88A4-9D45429697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09B55E79-36BC-4868-81A7-35AE9A1539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022795FB-4FCF-4074-A825-2DC62A6700C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D16A0347-ADFA-46BE-8EE1-9F6C4EABC0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37547EC7-6CC9-4F59-BEAF-F0FA8ECC31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slideLayout" Target="../slideLayouts/slideLayout145.xml"/><Relationship Id="rId3" Type="http://schemas.openxmlformats.org/officeDocument/2006/relationships/slideLayout" Target="../slideLayouts/slideLayout146.xml"/><Relationship Id="rId4" Type="http://schemas.openxmlformats.org/officeDocument/2006/relationships/slideLayout" Target="../slideLayouts/slideLayout147.xml"/><Relationship Id="rId5" Type="http://schemas.openxmlformats.org/officeDocument/2006/relationships/slideLayout" Target="../slideLayouts/slideLayout148.xml"/><Relationship Id="rId6" Type="http://schemas.openxmlformats.org/officeDocument/2006/relationships/slideLayout" Target="../slideLayouts/slideLayout149.xml"/><Relationship Id="rId7" Type="http://schemas.openxmlformats.org/officeDocument/2006/relationships/slideLayout" Target="../slideLayouts/slideLayout150.xml"/><Relationship Id="rId8" Type="http://schemas.openxmlformats.org/officeDocument/2006/relationships/slideLayout" Target="../slideLayouts/slideLayout151.xml"/><Relationship Id="rId9" Type="http://schemas.openxmlformats.org/officeDocument/2006/relationships/slideLayout" Target="../slideLayouts/slideLayout152.xml"/><Relationship Id="rId10" Type="http://schemas.openxmlformats.org/officeDocument/2006/relationships/slideLayout" Target="../slideLayouts/slideLayout153.xml"/><Relationship Id="rId11" Type="http://schemas.openxmlformats.org/officeDocument/2006/relationships/slideLayout" Target="../slideLayouts/slideLayout154.xml"/><Relationship Id="rId12" Type="http://schemas.openxmlformats.org/officeDocument/2006/relationships/slideLayout" Target="../slideLayouts/slideLayout155.xml"/><Relationship Id="rId13" Type="http://schemas.openxmlformats.org/officeDocument/2006/relationships/slideLayout" Target="../slideLayouts/slideLayout156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ADFF05-4CAA-47A6-BDCF-4AC4820693D0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PlaceHolder 1"/>
          <p:cNvSpPr>
            <a:spLocks noGrp="1"/>
          </p:cNvSpPr>
          <p:nvPr>
            <p:ph type="sldNum" idx="28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7DA894-FAE3-4911-918A-0400101BC74F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0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1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2" name="PlaceHolder 4"/>
          <p:cNvSpPr>
            <a:spLocks noGrp="1"/>
          </p:cNvSpPr>
          <p:nvPr>
            <p:ph type="dt" idx="29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3" name="PlaceHolder 5"/>
          <p:cNvSpPr>
            <a:spLocks noGrp="1"/>
          </p:cNvSpPr>
          <p:nvPr>
            <p:ph type="ftr" idx="30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0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PlaceHolder 1"/>
          <p:cNvSpPr>
            <a:spLocks noGrp="1"/>
          </p:cNvSpPr>
          <p:nvPr>
            <p:ph type="sldNum" idx="31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3627CCE-C366-4DC7-A559-4B3D965206DD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2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3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4" name="PlaceHolder 4"/>
          <p:cNvSpPr>
            <a:spLocks noGrp="1"/>
          </p:cNvSpPr>
          <p:nvPr>
            <p:ph type="dt" idx="32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5" name="PlaceHolder 5"/>
          <p:cNvSpPr>
            <a:spLocks noGrp="1"/>
          </p:cNvSpPr>
          <p:nvPr>
            <p:ph type="ftr" idx="33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2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PlaceHolder 1"/>
          <p:cNvSpPr>
            <a:spLocks noGrp="1"/>
          </p:cNvSpPr>
          <p:nvPr>
            <p:ph type="sldNum" idx="34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D8105B-E138-4D2E-9349-3565E860D55F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4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5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6" name="PlaceHolder 4"/>
          <p:cNvSpPr>
            <a:spLocks noGrp="1"/>
          </p:cNvSpPr>
          <p:nvPr>
            <p:ph type="dt" idx="35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7" name="PlaceHolder 5"/>
          <p:cNvSpPr>
            <a:spLocks noGrp="1"/>
          </p:cNvSpPr>
          <p:nvPr>
            <p:ph type="ftr" idx="36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4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Title Placeholder 1"/>
          <p:cNvSpPr/>
          <p:nvPr/>
        </p:nvSpPr>
        <p:spPr>
          <a:xfrm>
            <a:off x="457200" y="351000"/>
            <a:ext cx="8229600" cy="102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3000" spc="-1" strike="noStrike">
                <a:solidFill>
                  <a:srgbClr val="000000"/>
                </a:solidFill>
                <a:latin typeface="Times New Roman"/>
                <a:ea typeface="Arial"/>
              </a:rPr>
              <a:t>SCM6 White Label Figure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Footer Placeholder 4"/>
          <p:cNvSpPr/>
          <p:nvPr/>
        </p:nvSpPr>
        <p:spPr>
          <a:xfrm>
            <a:off x="3124080" y="6248520"/>
            <a:ext cx="388620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Arial"/>
                <a:ea typeface="Arial"/>
              </a:rPr>
              <a:t>Copyright © The Publisher. All rights reserv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PlaceHolder 1"/>
          <p:cNvSpPr>
            <a:spLocks noGrp="1"/>
          </p:cNvSpPr>
          <p:nvPr>
            <p:ph type="dt" idx="37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8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9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2"/>
    <p:sldLayoutId id="2147483806" r:id="rId3"/>
    <p:sldLayoutId id="2147483807" r:id="rId4"/>
    <p:sldLayoutId id="2147483808" r:id="rId5"/>
    <p:sldLayoutId id="2147483809" r:id="rId6"/>
    <p:sldLayoutId id="2147483810" r:id="rId7"/>
    <p:sldLayoutId id="2147483811" r:id="rId8"/>
    <p:sldLayoutId id="2147483812" r:id="rId9"/>
    <p:sldLayoutId id="2147483813" r:id="rId10"/>
    <p:sldLayoutId id="2147483814" r:id="rId11"/>
    <p:sldLayoutId id="2147483815" r:id="rId12"/>
    <p:sldLayoutId id="2147483816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1"/>
          <p:cNvSpPr>
            <a:spLocks noGrp="1"/>
          </p:cNvSpPr>
          <p:nvPr>
            <p:ph type="sldNum" idx="4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057A9B-4F61-4BBB-BB65-66282D454703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 type="dt" idx="5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 type="ftr" idx="6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1"/>
          <p:cNvSpPr>
            <a:spLocks noGrp="1"/>
          </p:cNvSpPr>
          <p:nvPr>
            <p:ph type="sldNum" idx="7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8F1D988-8326-499A-9E94-4D03A30D96A2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7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8" name="PlaceHolder 4"/>
          <p:cNvSpPr>
            <a:spLocks noGrp="1"/>
          </p:cNvSpPr>
          <p:nvPr>
            <p:ph type="dt" idx="8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PlaceHolder 5"/>
          <p:cNvSpPr>
            <a:spLocks noGrp="1"/>
          </p:cNvSpPr>
          <p:nvPr>
            <p:ph type="ftr" idx="9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1"/>
          <p:cNvSpPr>
            <a:spLocks noGrp="1"/>
          </p:cNvSpPr>
          <p:nvPr>
            <p:ph type="sldNum" idx="10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1DF3B7-7161-4870-BEB8-506CAA7095CA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9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0" name="PlaceHolder 4"/>
          <p:cNvSpPr>
            <a:spLocks noGrp="1"/>
          </p:cNvSpPr>
          <p:nvPr>
            <p:ph type="dt" idx="11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PlaceHolder 5"/>
          <p:cNvSpPr>
            <a:spLocks noGrp="1"/>
          </p:cNvSpPr>
          <p:nvPr>
            <p:ph type="ftr" idx="12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PlaceHolder 1"/>
          <p:cNvSpPr>
            <a:spLocks noGrp="1"/>
          </p:cNvSpPr>
          <p:nvPr>
            <p:ph type="sldNum" idx="13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6EC1664-16DB-42F8-8447-170D5060DA8A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1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2" name="PlaceHolder 4"/>
          <p:cNvSpPr>
            <a:spLocks noGrp="1"/>
          </p:cNvSpPr>
          <p:nvPr>
            <p:ph type="dt" idx="14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PlaceHolder 5"/>
          <p:cNvSpPr>
            <a:spLocks noGrp="1"/>
          </p:cNvSpPr>
          <p:nvPr>
            <p:ph type="ftr" idx="15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PlaceHolder 1"/>
          <p:cNvSpPr>
            <a:spLocks noGrp="1"/>
          </p:cNvSpPr>
          <p:nvPr>
            <p:ph type="sldNum" idx="16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71C5DD-1FD7-4CAC-B3E6-B99B6825C063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3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4" name="PlaceHolder 4"/>
          <p:cNvSpPr>
            <a:spLocks noGrp="1"/>
          </p:cNvSpPr>
          <p:nvPr>
            <p:ph type="dt" idx="17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5" name="PlaceHolder 5"/>
          <p:cNvSpPr>
            <a:spLocks noGrp="1"/>
          </p:cNvSpPr>
          <p:nvPr>
            <p:ph type="ftr" idx="18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2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PlaceHolder 1"/>
          <p:cNvSpPr>
            <a:spLocks noGrp="1"/>
          </p:cNvSpPr>
          <p:nvPr>
            <p:ph type="sldNum" idx="19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0F5D15-222C-4BD8-B081-FAED04D40881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5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6" name="PlaceHolder 4"/>
          <p:cNvSpPr>
            <a:spLocks noGrp="1"/>
          </p:cNvSpPr>
          <p:nvPr>
            <p:ph type="dt" idx="20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7" name="PlaceHolder 5"/>
          <p:cNvSpPr>
            <a:spLocks noGrp="1"/>
          </p:cNvSpPr>
          <p:nvPr>
            <p:ph type="ftr" idx="21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PlaceHolder 1"/>
          <p:cNvSpPr>
            <a:spLocks noGrp="1"/>
          </p:cNvSpPr>
          <p:nvPr>
            <p:ph type="sldNum" idx="22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718E40-2F7E-4A10-A0F0-7144B07779E8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6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97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98" name="PlaceHolder 4"/>
          <p:cNvSpPr>
            <a:spLocks noGrp="1"/>
          </p:cNvSpPr>
          <p:nvPr>
            <p:ph type="dt" idx="23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9" name="PlaceHolder 5"/>
          <p:cNvSpPr>
            <a:spLocks noGrp="1"/>
          </p:cNvSpPr>
          <p:nvPr>
            <p:ph type="ftr" idx="24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6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PlaceHolder 1"/>
          <p:cNvSpPr>
            <a:spLocks noGrp="1"/>
          </p:cNvSpPr>
          <p:nvPr>
            <p:ph type="sldNum" idx="25"/>
          </p:nvPr>
        </p:nvSpPr>
        <p:spPr>
          <a:xfrm rot="16200000"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146D9F-B66E-4F2C-B3FD-C1A209F08348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6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1" marL="343080" indent="-343080">
              <a:spcBef>
                <a:spcPts val="26"/>
              </a:spcBef>
              <a:buClr>
                <a:srgbClr val="ffffff"/>
              </a:buClr>
              <a:buFont typeface="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2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3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4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5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  <a:p>
            <a:pPr lvl="6">
              <a:spcBef>
                <a:spcPts val="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0" name="PlaceHolder 4"/>
          <p:cNvSpPr>
            <a:spLocks noGrp="1"/>
          </p:cNvSpPr>
          <p:nvPr>
            <p:ph type="dt" idx="26"/>
          </p:nvPr>
        </p:nvSpPr>
        <p:spPr>
          <a:xfrm rot="16200000"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1" name="PlaceHolder 5"/>
          <p:cNvSpPr>
            <a:spLocks noGrp="1"/>
          </p:cNvSpPr>
          <p:nvPr>
            <p:ph type="ftr" idx="27"/>
          </p:nvPr>
        </p:nvSpPr>
        <p:spPr>
          <a:xfrm rot="16200000"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Arial"/>
              </a:rPr>
              <a:t>Copyright © 2012 American Medical Association. All rights reserved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2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6" name="Rectangle 10"/>
          <p:cNvSpPr/>
          <p:nvPr/>
        </p:nvSpPr>
        <p:spPr>
          <a:xfrm>
            <a:off x="0" y="687240"/>
            <a:ext cx="9144000" cy="914400"/>
          </a:xfrm>
          <a:prstGeom prst="rect">
            <a:avLst/>
          </a:prstGeom>
          <a:solidFill>
            <a:srgbClr val="eeeeee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Date Placeholder 3"/>
          <p:cNvSpPr/>
          <p:nvPr/>
        </p:nvSpPr>
        <p:spPr>
          <a:xfrm>
            <a:off x="0" y="6222960"/>
            <a:ext cx="2540160" cy="63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54160" rIns="127080" tIns="63360" bIns="63360" anchor="ctr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 baseline="256000">
                <a:solidFill>
                  <a:srgbClr val="999999"/>
                </a:solidFill>
                <a:latin typeface="Arial"/>
              </a:rPr>
              <a:t>Date of download:  1/8/202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Footer Placeholder 4"/>
          <p:cNvSpPr/>
          <p:nvPr/>
        </p:nvSpPr>
        <p:spPr>
          <a:xfrm>
            <a:off x="2971800" y="6222960"/>
            <a:ext cx="3200400" cy="63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 baseline="256000">
                <a:solidFill>
                  <a:srgbClr val="999999"/>
                </a:solidFill>
                <a:latin typeface="Arial"/>
              </a:rPr>
              <a:t>Copyright 2023 American Medical Association. All Rights Reserved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Text Placeholder 2"/>
          <p:cNvSpPr/>
          <p:nvPr/>
        </p:nvSpPr>
        <p:spPr>
          <a:xfrm>
            <a:off x="0" y="692280"/>
            <a:ext cx="9144000" cy="50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54160" rIns="127080" tIns="6336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From: </a:t>
            </a:r>
            <a:r>
              <a:rPr b="1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Reporting of Factorial Randomized Trials: Extension of the CONSORT 2010 Statement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Straight Connector 8"/>
          <p:cNvSpPr/>
          <p:nvPr/>
        </p:nvSpPr>
        <p:spPr>
          <a:xfrm flipV="1">
            <a:off x="0" y="6215040"/>
            <a:ext cx="9144000" cy="7920"/>
          </a:xfrm>
          <a:prstGeom prst="line">
            <a:avLst/>
          </a:prstGeom>
          <a:ln w="12600">
            <a:solidFill>
              <a:srgbClr val="99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Text Placeholder 2"/>
          <p:cNvSpPr/>
          <p:nvPr/>
        </p:nvSpPr>
        <p:spPr>
          <a:xfrm>
            <a:off x="0" y="1282680"/>
            <a:ext cx="914400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54160" rIns="127080" tIns="0" bIns="633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JAMA. 2023;330(21):2106-2114. doi:10.1001/jama.2023.1979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Text Placeholder 2"/>
          <p:cNvSpPr/>
          <p:nvPr/>
        </p:nvSpPr>
        <p:spPr>
          <a:xfrm>
            <a:off x="0" y="5575320"/>
            <a:ext cx="9144000" cy="63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54160" rIns="0" tIns="0" bIns="63360" anchor="t">
            <a:noAutofit/>
          </a:bodyPr>
          <a:p>
            <a:pPr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tems to Include When Reporting a Randomized Factorial Trial in a Journal or Conference Abstract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a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The CONSORT-factorial Abstract Checklist is licensed by the CONSORT-factorial Group under the Creative Commons Attribution-NonCommercial-NoDerivs 4.0 International licens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 This item is specific to conference abstract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TextBox 11"/>
          <p:cNvSpPr/>
          <p:nvPr/>
        </p:nvSpPr>
        <p:spPr>
          <a:xfrm>
            <a:off x="0" y="5305320"/>
            <a:ext cx="9153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54160" rIns="0" tIns="0" bIns="63360" anchor="t">
            <a:normAutofit fontScale="36000"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256000">
                <a:solidFill>
                  <a:srgbClr val="ffffff"/>
                </a:solidFill>
                <a:latin typeface="Arial"/>
              </a:rPr>
              <a:t>Table Title: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Straight Connector 5"/>
          <p:cNvSpPr/>
          <p:nvPr/>
        </p:nvSpPr>
        <p:spPr>
          <a:xfrm>
            <a:off x="0" y="666720"/>
            <a:ext cx="9144000" cy="0"/>
          </a:xfrm>
          <a:prstGeom prst="line">
            <a:avLst/>
          </a:prstGeom>
          <a:ln w="38160">
            <a:solidFill>
              <a:srgbClr val="99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5" name="Picture 18" descr=""/>
          <p:cNvPicPr/>
          <p:nvPr/>
        </p:nvPicPr>
        <p:blipFill>
          <a:blip r:embed="rId1"/>
          <a:stretch/>
        </p:blipFill>
        <p:spPr>
          <a:xfrm>
            <a:off x="254160" y="101520"/>
            <a:ext cx="2286000" cy="482760"/>
          </a:xfrm>
          <a:prstGeom prst="rect">
            <a:avLst/>
          </a:prstGeom>
          <a:ln w="0">
            <a:noFill/>
          </a:ln>
        </p:spPr>
      </p:pic>
      <p:pic>
        <p:nvPicPr>
          <p:cNvPr id="556" name="New picture" descr=""/>
          <p:cNvPicPr/>
          <p:nvPr/>
        </p:nvPicPr>
        <p:blipFill>
          <a:blip r:embed="rId2"/>
          <a:stretch/>
        </p:blipFill>
        <p:spPr>
          <a:xfrm>
            <a:off x="2666880" y="2057400"/>
            <a:ext cx="3814920" cy="3086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8T21:44:13Z</dcterms:created>
  <dc:creator>Holly Auten</dc:creator>
  <dc:description/>
  <dc:language>en-US</dc:language>
  <cp:lastModifiedBy>Lindsay Jacobik</cp:lastModifiedBy>
  <dcterms:modified xsi:type="dcterms:W3CDTF">2025-01-08T09:43:42Z</dcterms:modified>
  <cp:revision>56</cp:revision>
  <dc:subject/>
  <dc:title>Slide 1</dc:title>
</cp:coreProperties>
</file>